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711" autoAdjust="0"/>
    <p:restoredTop sz="94660"/>
  </p:normalViewPr>
  <p:slideViewPr>
    <p:cSldViewPr snapToGrid="0">
      <p:cViewPr varScale="1">
        <p:scale>
          <a:sx n="77" d="100"/>
          <a:sy n="77" d="100"/>
        </p:scale>
        <p:origin x="402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48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616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733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377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198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784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252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192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876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49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548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5B320C-0161-497E-BC62-4867AB485E89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EAC09-A791-4AAE-8CC2-78CD48CC9D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996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0440192"/>
              </p:ext>
            </p:extLst>
          </p:nvPr>
        </p:nvGraphicFramePr>
        <p:xfrm>
          <a:off x="1933800" y="1255183"/>
          <a:ext cx="6897991" cy="2910794"/>
        </p:xfrm>
        <a:graphic>
          <a:graphicData uri="http://schemas.openxmlformats.org/drawingml/2006/table">
            <a:tbl>
              <a:tblPr/>
              <a:tblGrid>
                <a:gridCol w="41452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001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903477362"/>
                    </a:ext>
                  </a:extLst>
                </a:gridCol>
              </a:tblGrid>
              <a:tr h="445846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uster a.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thway analysis for H3K27M 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sus 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cells at day 5 post-differentiation (642 genes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08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-Te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en-US" sz="1100" b="1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Ge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cription factor activity, sequence-specific DNA bind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230875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cRN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etabolic proces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cRN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process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gulation of neuron differenti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525168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dium ion transpo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asive growt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3846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Subset of enriched pathways for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3K27M vs WT cells at day 5 post-differentiation-Cluster 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42292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923B24F-CA0E-4479-A5B3-952CEAD175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5430205"/>
              </p:ext>
            </p:extLst>
          </p:nvPr>
        </p:nvGraphicFramePr>
        <p:xfrm>
          <a:off x="2280934" y="168298"/>
          <a:ext cx="6894576" cy="6476954"/>
        </p:xfrm>
        <a:graphic>
          <a:graphicData uri="http://schemas.openxmlformats.org/drawingml/2006/table">
            <a:tbl>
              <a:tblPr/>
              <a:tblGrid>
                <a:gridCol w="41422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99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3312">
                  <a:extLst>
                    <a:ext uri="{9D8B030D-6E8A-4147-A177-3AD203B41FA5}">
                      <a16:colId xmlns:a16="http://schemas.microsoft.com/office/drawing/2014/main" val="903477362"/>
                    </a:ext>
                  </a:extLst>
                </a:gridCol>
              </a:tblGrid>
              <a:tr h="445846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uster b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thway analysis for H3K27M 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sus 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cells at day 5 post-differentiation (1365 genes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08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-Te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en-US" sz="1100" b="1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Ge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romosome aberration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oblasto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230875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itive regulation of metabolic proces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pid metabolis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&lt;0.0001</a:t>
                      </a:r>
                      <a:endParaRPr kumimoji="0" 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deat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&lt;0.0001</a:t>
                      </a:r>
                      <a:endParaRPr kumimoji="0" 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525168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prolifer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&lt;0.0001</a:t>
                      </a:r>
                      <a:endParaRPr kumimoji="0" 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umor angiogenesi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invas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594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umor progress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&lt;0.0001</a:t>
                      </a:r>
                      <a:endParaRPr kumimoji="0" 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390829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poxi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059628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al stem cel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168198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inoblasto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145810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trix Metalloproteina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903341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odevelopmental disorde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797547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modulin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bind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581797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al cell differenti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03036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em cell differenti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37711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egrin linked kina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575077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atidylinositol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sphosphate bind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859945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MP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bind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3974686"/>
                  </a:ext>
                </a:extLst>
              </a:tr>
              <a:tr h="193846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Subset of enriched pathways for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3K27M vs WT cells at day 5 post-differentiation-Cluster 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31342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2E90DCF-9E0A-4793-958D-6BE8E9CF2D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2887311"/>
              </p:ext>
            </p:extLst>
          </p:nvPr>
        </p:nvGraphicFramePr>
        <p:xfrm>
          <a:off x="2756076" y="1703917"/>
          <a:ext cx="6894576" cy="2087834"/>
        </p:xfrm>
        <a:graphic>
          <a:graphicData uri="http://schemas.openxmlformats.org/drawingml/2006/table">
            <a:tbl>
              <a:tblPr/>
              <a:tblGrid>
                <a:gridCol w="41422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99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3312">
                  <a:extLst>
                    <a:ext uri="{9D8B030D-6E8A-4147-A177-3AD203B41FA5}">
                      <a16:colId xmlns:a16="http://schemas.microsoft.com/office/drawing/2014/main" val="903477362"/>
                    </a:ext>
                  </a:extLst>
                </a:gridCol>
              </a:tblGrid>
              <a:tr h="445846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uster c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thway analysis for 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versus H3K27M 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 at day 0 post-differentiation (213 genes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08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-Te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en-US" sz="1100" b="1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Ge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oplasms, Neuro-epitheli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gulation of RNA metabolic proces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230875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cription factor activity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nd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nd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botropic glutamate receptor signal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3846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Subset of enriched pathways for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3K27M vs WT cells at day 0 post-differentiation-Cluster 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256844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70D14CB-520E-432B-B88E-7F22391A53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1811750"/>
              </p:ext>
            </p:extLst>
          </p:nvPr>
        </p:nvGraphicFramePr>
        <p:xfrm>
          <a:off x="2696810" y="670463"/>
          <a:ext cx="6894576" cy="4831034"/>
        </p:xfrm>
        <a:graphic>
          <a:graphicData uri="http://schemas.openxmlformats.org/drawingml/2006/table">
            <a:tbl>
              <a:tblPr/>
              <a:tblGrid>
                <a:gridCol w="41422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99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3312">
                  <a:extLst>
                    <a:ext uri="{9D8B030D-6E8A-4147-A177-3AD203B41FA5}">
                      <a16:colId xmlns:a16="http://schemas.microsoft.com/office/drawing/2014/main" val="903477362"/>
                    </a:ext>
                  </a:extLst>
                </a:gridCol>
              </a:tblGrid>
              <a:tr h="445846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uster d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thway analysis for 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sus 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3K27M 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 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 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5 post-differentiation (608 genes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086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-Te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en-US" sz="1100" b="1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Ge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Transformation, Neoplasti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po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230875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differenti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prolifer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&lt;0.0001</a:t>
                      </a:r>
                      <a:endParaRPr kumimoji="0" 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dulloblasto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525168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NA polymerase II transcription factor activity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nd bind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owth arres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r>
                        <a:rPr lang="en-US" sz="1100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rocytom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594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rge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tumor suppresso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390829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em cell prolifer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059628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gulation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of cell divis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168198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oltage-gated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tassium channel activ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145810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UB1 Mitotic checkpoint serine/ threonine kinase 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903341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utamate receptor activ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7975472"/>
                  </a:ext>
                </a:extLst>
              </a:tr>
              <a:tr h="193846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Subset of enriched pathways for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cells at day 0 vs day 5 post-differentiation-Cluster 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770875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A851AE4-29EF-42E7-882E-328FA619E2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2277060"/>
              </p:ext>
            </p:extLst>
          </p:nvPr>
        </p:nvGraphicFramePr>
        <p:xfrm>
          <a:off x="2747609" y="1730586"/>
          <a:ext cx="6894576" cy="2081777"/>
        </p:xfrm>
        <a:graphic>
          <a:graphicData uri="http://schemas.openxmlformats.org/drawingml/2006/table">
            <a:tbl>
              <a:tblPr/>
              <a:tblGrid>
                <a:gridCol w="41422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99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53312">
                  <a:extLst>
                    <a:ext uri="{9D8B030D-6E8A-4147-A177-3AD203B41FA5}">
                      <a16:colId xmlns:a16="http://schemas.microsoft.com/office/drawing/2014/main" val="903477362"/>
                    </a:ext>
                  </a:extLst>
                </a:gridCol>
              </a:tblGrid>
              <a:tr h="445846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uster e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thway analysis for H3K27M cells 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sus WT cells at 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5 post-differentiation (378 genes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-Ter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en-US" sz="1100" b="1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Ge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pid metabolic proces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porter activ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0E-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230875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ffick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0E-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uregul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3846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Subset of enriched pathways for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3K27M cells at day 0 vs day 5 post-differentiation-Cluster 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44890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08</TotalTime>
  <Words>451</Words>
  <Application>Microsoft Office PowerPoint</Application>
  <PresentationFormat>Widescreen</PresentationFormat>
  <Paragraphs>17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umont</dc:creator>
  <cp:lastModifiedBy>Kfoury-Beaumont, Najla</cp:lastModifiedBy>
  <cp:revision>196</cp:revision>
  <cp:lastPrinted>2018-08-13T21:09:23Z</cp:lastPrinted>
  <dcterms:created xsi:type="dcterms:W3CDTF">2015-09-29T20:17:17Z</dcterms:created>
  <dcterms:modified xsi:type="dcterms:W3CDTF">2021-10-08T20:17:22Z</dcterms:modified>
</cp:coreProperties>
</file>